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8" r:id="rId2"/>
    <p:sldId id="511" r:id="rId3"/>
    <p:sldId id="555" r:id="rId4"/>
    <p:sldId id="546" r:id="rId5"/>
    <p:sldId id="554" r:id="rId6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D3B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65" autoAdjust="0"/>
    <p:restoredTop sz="94660"/>
  </p:normalViewPr>
  <p:slideViewPr>
    <p:cSldViewPr snapToGrid="0">
      <p:cViewPr varScale="1">
        <p:scale>
          <a:sx n="130" d="100"/>
          <a:sy n="130" d="100"/>
        </p:scale>
        <p:origin x="713" y="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ddori\Desktop\Data%20FIKK1%20paper%20for%20Plos%20Pathog\Donn&#233;es%20%20ElisaFIKK1-1-6%20et%20VHH\donn&#233;s%20foldchnage%20ELISA%20FIKK1%20-VHH-%20VAR2%2009-09-22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JPSEMBLAT\Documents\DossierDomi\FACS\FIKK\FIKK_Rapa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Graphique%20dans%20Microsoft%20PowerPoint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Graphique%20dans%20Microsoft%20PowerPoint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Plasmodium%203\Documents\DDS%20PROJETS%20LABO%20%20Benoit\NF54CSA%20Londres\HAFIKK1%20juin%20juillet%20aout2020\qRTPCR\qPCR%20NF54%20WT%20Rapa%20%2002-07-2020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données!$G$4,données!$G$6)</c:f>
                <c:numCache>
                  <c:formatCode>General</c:formatCode>
                  <c:ptCount val="2"/>
                  <c:pt idx="0">
                    <c:v>0.1975685535031646</c:v>
                  </c:pt>
                  <c:pt idx="1">
                    <c:v>1.58054842802533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données!$B$4,données!$B$6)</c:f>
              <c:strCache>
                <c:ptCount val="2"/>
                <c:pt idx="0">
                  <c:v>VHH</c:v>
                </c:pt>
                <c:pt idx="1">
                  <c:v>FIKK1</c:v>
                </c:pt>
              </c:strCache>
            </c:strRef>
          </c:cat>
          <c:val>
            <c:numRef>
              <c:f>(données!$F$4,données!$F$6)</c:f>
              <c:numCache>
                <c:formatCode>General</c:formatCode>
                <c:ptCount val="2"/>
                <c:pt idx="0">
                  <c:v>1.3833333333333335</c:v>
                </c:pt>
                <c:pt idx="1">
                  <c:v>10.89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54-4328-A587-CD44AD0C4D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0"/>
        <c:axId val="1339730191"/>
        <c:axId val="1339724367"/>
      </c:barChart>
      <c:catAx>
        <c:axId val="13397301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39724367"/>
        <c:crosses val="autoZero"/>
        <c:auto val="1"/>
        <c:lblAlgn val="ctr"/>
        <c:lblOffset val="100"/>
        <c:noMultiLvlLbl val="0"/>
      </c:catAx>
      <c:valAx>
        <c:axId val="1339724367"/>
        <c:scaling>
          <c:orientation val="minMax"/>
          <c:max val="1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fr-FR" sz="1100" b="0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fr-FR" sz="11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change /PBS</a:t>
                </a:r>
                <a:endParaRPr lang="fr-FR" sz="11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8970189701897018E-2"/>
              <c:y val="0.283308415561978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bg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397301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811581572203385"/>
          <c:y val="0.10493960566603665"/>
          <c:w val="0.77223142081402674"/>
          <c:h val="0.76237233375802926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B0F0"/>
              </a:solidFill>
            </c:spPr>
            <c:extLst>
              <c:ext xmlns:c16="http://schemas.microsoft.com/office/drawing/2014/chart" uri="{C3380CC4-5D6E-409C-BE32-E72D297353CC}">
                <c16:uniqueId val="{00000001-E31B-424D-A5DF-EC76761DDD4E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E31B-424D-A5DF-EC76761DDD4E}"/>
              </c:ext>
            </c:extLst>
          </c:dPt>
          <c:errBars>
            <c:errBarType val="both"/>
            <c:errValType val="cust"/>
            <c:noEndCap val="0"/>
            <c:plus>
              <c:numRef>
                <c:f>Feuil1!$I$4:$I$5</c:f>
                <c:numCache>
                  <c:formatCode>General</c:formatCode>
                  <c:ptCount val="2"/>
                  <c:pt idx="0">
                    <c:v>1675.1454464214946</c:v>
                  </c:pt>
                  <c:pt idx="1">
                    <c:v>1680.4530341547782</c:v>
                  </c:pt>
                </c:numCache>
              </c:numRef>
            </c:plus>
            <c:minus>
              <c:numRef>
                <c:f>Feuil1!$I$4:$I$5</c:f>
                <c:numCache>
                  <c:formatCode>General</c:formatCode>
                  <c:ptCount val="2"/>
                  <c:pt idx="0">
                    <c:v>1675.1454464214946</c:v>
                  </c:pt>
                  <c:pt idx="1">
                    <c:v>1680.4530341547782</c:v>
                  </c:pt>
                </c:numCache>
              </c:numRef>
            </c:minus>
          </c:errBars>
          <c:cat>
            <c:strLit>
              <c:ptCount val="2"/>
              <c:pt idx="0">
                <c:v>DMSO</c:v>
              </c:pt>
              <c:pt idx="1">
                <c:v> Rapa</c:v>
              </c:pt>
            </c:strLit>
          </c:cat>
          <c:val>
            <c:numRef>
              <c:f>Feuil1!$H$4:$H$5</c:f>
              <c:numCache>
                <c:formatCode>General</c:formatCode>
                <c:ptCount val="2"/>
                <c:pt idx="0">
                  <c:v>5034.333333333333</c:v>
                </c:pt>
                <c:pt idx="1">
                  <c:v>51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31B-424D-A5DF-EC76761DDD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7"/>
        <c:overlap val="50"/>
        <c:axId val="5097728"/>
        <c:axId val="5902336"/>
      </c:barChart>
      <c:catAx>
        <c:axId val="509772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 b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5902336"/>
        <c:crosses val="autoZero"/>
        <c:auto val="1"/>
        <c:lblAlgn val="ctr"/>
        <c:lblOffset val="100"/>
        <c:noMultiLvlLbl val="0"/>
      </c:catAx>
      <c:valAx>
        <c:axId val="5902336"/>
        <c:scaling>
          <c:orientation val="minMax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/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5097728"/>
        <c:crosses val="autoZero"/>
        <c:crossBetween val="between"/>
        <c:majorUnit val="2000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fr-FR" sz="1050" b="0" i="0" baseline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atic</a:t>
            </a:r>
            <a:r>
              <a:rPr lang="fr-FR" sz="1050" b="0" i="0" baseline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50" b="0" i="0" baseline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adhesion</a:t>
            </a:r>
            <a:r>
              <a:rPr lang="fr-FR" sz="1050" b="0" i="0" baseline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96 </a:t>
            </a:r>
            <a:r>
              <a:rPr lang="fr-FR" sz="1050" b="0" i="0" baseline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ells</a:t>
            </a:r>
            <a:r>
              <a:rPr lang="fr-FR" sz="1050" b="0" i="0" baseline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05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050" b="0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6767298397542288"/>
          <c:y val="0.26303846178431484"/>
          <c:w val="0.7666537306464497"/>
          <c:h val="0.5794117271047870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D9969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0-4875-4B0E-AECE-B48CCBBBF145}"/>
              </c:ext>
            </c:extLst>
          </c:dPt>
          <c:dPt>
            <c:idx val="3"/>
            <c:invertIfNegative val="0"/>
            <c:bubble3D val="0"/>
            <c:spPr>
              <a:solidFill>
                <a:srgbClr val="D9969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875-4B0E-AECE-B48CCBBBF145}"/>
              </c:ext>
            </c:extLst>
          </c:dPt>
          <c:cat>
            <c:strRef>
              <c:f>'[Graphique dans Microsoft PowerPoint]Raw Data{time(s)-240;Wavelength'!$K$18,'[Graphique dans Microsoft PowerPoint]Raw Data{time(s)-240;Wavelength'!$K$19,'[Graphique dans Microsoft PowerPoint]Raw Data{time(s)-240;Wavelength'!$K$20,'[Graphique dans Microsoft PowerPoint]Raw Data{time(s)-240;Wavelength'!$K$21</c:f>
              <c:strCache>
                <c:ptCount val="4"/>
                <c:pt idx="0">
                  <c:v> BSA DMSO</c:v>
                </c:pt>
                <c:pt idx="1">
                  <c:v> BSA Rapa</c:v>
                </c:pt>
                <c:pt idx="2">
                  <c:v>CSA DMSO</c:v>
                </c:pt>
                <c:pt idx="3">
                  <c:v> CSA Rapa</c:v>
                </c:pt>
              </c:strCache>
            </c:strRef>
          </c:cat>
          <c:val>
            <c:numRef>
              <c:f>'[Graphique dans Microsoft PowerPoint]Raw Data{time(s)-240;Wavelength'!$L$18,'[Graphique dans Microsoft PowerPoint]Raw Data{time(s)-240;Wavelength'!$L$19,'[Graphique dans Microsoft PowerPoint]Raw Data{time(s)-240;Wavelength'!$L$20,'[Graphique dans Microsoft PowerPoint]Raw Data{time(s)-240;Wavelength'!$L$21</c:f>
              <c:numCache>
                <c:formatCode>General</c:formatCode>
                <c:ptCount val="4"/>
                <c:pt idx="0">
                  <c:v>0.1075</c:v>
                </c:pt>
                <c:pt idx="1">
                  <c:v>0.1205</c:v>
                </c:pt>
                <c:pt idx="2">
                  <c:v>0.61050000000000004</c:v>
                </c:pt>
                <c:pt idx="3">
                  <c:v>0.594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6D-4CD5-8059-9E4E0236B2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8261664"/>
        <c:axId val="318262056"/>
      </c:barChart>
      <c:catAx>
        <c:axId val="318261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18262056"/>
        <c:crosses val="autoZero"/>
        <c:auto val="1"/>
        <c:lblAlgn val="ctr"/>
        <c:lblOffset val="100"/>
        <c:noMultiLvlLbl val="0"/>
      </c:catAx>
      <c:valAx>
        <c:axId val="3182620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b="1" dirty="0"/>
                  <a:t>OD</a:t>
                </a:r>
                <a:r>
                  <a:rPr lang="fr-FR" dirty="0"/>
                  <a:t> </a:t>
                </a:r>
                <a:r>
                  <a:rPr lang="fr-FR" b="1" dirty="0"/>
                  <a:t>650nm</a:t>
                </a:r>
              </a:p>
            </c:rich>
          </c:tx>
          <c:layout>
            <c:manualLayout>
              <c:xMode val="edge"/>
              <c:yMode val="edge"/>
              <c:x val="1.2509197214881414E-2"/>
              <c:y val="0.41985117392499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rgbClr val="E7E6E6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18261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1050" b="0" i="0" baseline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atic</a:t>
            </a:r>
            <a:r>
              <a:rPr lang="fr-FR" sz="1050" b="0" i="0" baseline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50" b="0" i="0" baseline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ytoadhesion</a:t>
            </a:r>
            <a:r>
              <a:rPr lang="fr-FR" sz="1050" b="0" i="0" baseline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Petri </a:t>
            </a:r>
            <a:r>
              <a:rPr lang="fr-FR" sz="1050" b="0" i="0" baseline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sh</a:t>
            </a:r>
            <a:r>
              <a:rPr lang="fr-FR" sz="1050" b="0" i="0" baseline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fr-FR" sz="105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>
                <a:solidFill>
                  <a:prstClr val="black">
                    <a:lumMod val="65000"/>
                    <a:lumOff val="35000"/>
                  </a:prstClr>
                </a:solidFill>
              </a:defRPr>
            </a:pPr>
            <a:endParaRPr lang="fr-FR" b="1" baseline="0" dirty="0"/>
          </a:p>
        </c:rich>
      </c:tx>
      <c:layout>
        <c:manualLayout>
          <c:xMode val="edge"/>
          <c:yMode val="edge"/>
          <c:x val="0.28008379577034298"/>
          <c:y val="5.85439706303719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D9969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0-CD3F-47A2-9B11-E617278C2FC3}"/>
              </c:ext>
            </c:extLst>
          </c:dPt>
          <c:errBars>
            <c:errBarType val="both"/>
            <c:errValType val="cust"/>
            <c:noEndCap val="0"/>
            <c:plus>
              <c:numRef>
                <c:f>'[Graphique dans Microsoft PowerPoint]Feuil2'!$B$7,'[Graphique dans Microsoft PowerPoint]Feuil2'!$B$15</c:f>
                <c:numCache>
                  <c:formatCode>General</c:formatCode>
                  <c:ptCount val="2"/>
                  <c:pt idx="0">
                    <c:v>7.5696763471102217</c:v>
                  </c:pt>
                  <c:pt idx="1">
                    <c:v>5.61248608016091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Graphique dans Microsoft PowerPoint]Feuil2'!$F$2,'[Graphique dans Microsoft PowerPoint]Feuil2'!$F$5</c:f>
              <c:strCache>
                <c:ptCount val="2"/>
                <c:pt idx="0">
                  <c:v> CSA DMSO</c:v>
                </c:pt>
                <c:pt idx="1">
                  <c:v> Rapa</c:v>
                </c:pt>
              </c:strCache>
            </c:strRef>
          </c:cat>
          <c:val>
            <c:numRef>
              <c:f>'[Graphique dans Microsoft PowerPoint]Feuil2'!$G$2,'[Graphique dans Microsoft PowerPoint]Feuil2'!$G$5</c:f>
              <c:numCache>
                <c:formatCode>General</c:formatCode>
                <c:ptCount val="2"/>
                <c:pt idx="0">
                  <c:v>21.4</c:v>
                </c:pt>
                <c:pt idx="1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1A-4352-BFA8-7EE3652F1B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0"/>
        <c:overlap val="-27"/>
        <c:axId val="481802056"/>
        <c:axId val="272199904"/>
      </c:barChart>
      <c:catAx>
        <c:axId val="481802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72199904"/>
        <c:crosses val="autoZero"/>
        <c:auto val="1"/>
        <c:lblAlgn val="ctr"/>
        <c:lblOffset val="100"/>
        <c:noMultiLvlLbl val="0"/>
      </c:catAx>
      <c:valAx>
        <c:axId val="272199904"/>
        <c:scaling>
          <c:orientation val="minMax"/>
          <c:max val="4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050" b="0" baseline="0" dirty="0" err="1"/>
                  <a:t>Bound</a:t>
                </a:r>
                <a:r>
                  <a:rPr lang="fr-FR" sz="1050" b="0" baseline="0" dirty="0"/>
                  <a:t>  </a:t>
                </a:r>
                <a:r>
                  <a:rPr lang="fr-FR" sz="1050" b="0" baseline="0" dirty="0" err="1"/>
                  <a:t>IEs</a:t>
                </a:r>
                <a:endParaRPr lang="fr-FR" sz="1050" b="0" dirty="0"/>
              </a:p>
            </c:rich>
          </c:tx>
          <c:layout>
            <c:manualLayout>
              <c:xMode val="edge"/>
              <c:yMode val="edge"/>
              <c:x val="3.9368015765432248E-3"/>
              <c:y val="0.424927685433543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rgbClr val="E7E6E6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8180205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485992466593372"/>
          <c:y val="0.18938108871211698"/>
          <c:w val="0.73885191476897305"/>
          <c:h val="0.70836688652974911"/>
        </c:manualLayout>
      </c:layout>
      <c:pieChart>
        <c:varyColors val="1"/>
        <c:ser>
          <c:idx val="0"/>
          <c:order val="0"/>
          <c:tx>
            <c:strRef>
              <c:f>'NF54'!$K$2</c:f>
              <c:strCache>
                <c:ptCount val="1"/>
                <c:pt idx="0">
                  <c:v>NF54 EPCR 4X</c:v>
                </c:pt>
              </c:strCache>
            </c:strRef>
          </c:tx>
          <c:dLbls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FE1F-4219-8B18-61E285D73B37}"/>
                </c:ext>
              </c:extLst>
            </c:dLbl>
            <c:dLbl>
              <c:idx val="1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FE1F-4219-8B18-61E285D73B37}"/>
                </c:ext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FE1F-4219-8B18-61E285D73B37}"/>
                </c:ext>
              </c:extLst>
            </c:dLbl>
            <c:dLbl>
              <c:idx val="1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FE1F-4219-8B18-61E285D73B37}"/>
                </c:ext>
              </c:extLst>
            </c:dLbl>
            <c:dLbl>
              <c:idx val="1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FE1F-4219-8B18-61E285D73B37}"/>
                </c:ext>
              </c:extLst>
            </c:dLbl>
            <c:dLbl>
              <c:idx val="1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FE1F-4219-8B18-61E285D73B37}"/>
                </c:ext>
              </c:extLst>
            </c:dLbl>
            <c:dLbl>
              <c:idx val="2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FE1F-4219-8B18-61E285D73B37}"/>
                </c:ext>
              </c:extLst>
            </c:dLbl>
            <c:dLbl>
              <c:idx val="2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FE1F-4219-8B18-61E285D73B37}"/>
                </c:ext>
              </c:extLst>
            </c:dLbl>
            <c:dLbl>
              <c:idx val="2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FE1F-4219-8B18-61E285D73B37}"/>
                </c:ext>
              </c:extLst>
            </c:dLbl>
            <c:dLbl>
              <c:idx val="3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FE1F-4219-8B18-61E285D73B37}"/>
                </c:ext>
              </c:extLst>
            </c:dLbl>
            <c:dLbl>
              <c:idx val="3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FE1F-4219-8B18-61E285D73B37}"/>
                </c:ext>
              </c:extLst>
            </c:dLbl>
            <c:dLbl>
              <c:idx val="3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FE1F-4219-8B18-61E285D73B37}"/>
                </c:ext>
              </c:extLst>
            </c:dLbl>
            <c:dLbl>
              <c:idx val="3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FE1F-4219-8B18-61E285D73B37}"/>
                </c:ext>
              </c:extLst>
            </c:dLbl>
            <c:dLbl>
              <c:idx val="4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FE1F-4219-8B18-61E285D73B37}"/>
                </c:ext>
              </c:extLst>
            </c:dLbl>
            <c:dLbl>
              <c:idx val="4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FE1F-4219-8B18-61E285D73B37}"/>
                </c:ext>
              </c:extLst>
            </c:dLbl>
            <c:dLbl>
              <c:idx val="4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FE1F-4219-8B18-61E285D73B37}"/>
                </c:ext>
              </c:extLst>
            </c:dLbl>
            <c:dLbl>
              <c:idx val="4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0-FE1F-4219-8B18-61E285D73B37}"/>
                </c:ext>
              </c:extLst>
            </c:dLbl>
            <c:dLbl>
              <c:idx val="4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FE1F-4219-8B18-61E285D73B37}"/>
                </c:ext>
              </c:extLst>
            </c:dLbl>
            <c:dLbl>
              <c:idx val="55"/>
              <c:layout>
                <c:manualLayout>
                  <c:x val="-7.4723536172687482E-2"/>
                  <c:y val="-0.30752965911709951"/>
                </c:manualLayout>
              </c:layout>
              <c:tx>
                <c:rich>
                  <a:bodyPr/>
                  <a:lstStyle/>
                  <a:p>
                    <a:fld id="{3CB23E91-03CF-49BC-BE1F-25E25BE2C86F}" type="CATEGORYNAME">
                      <a:rPr lang="en-US" sz="900" b="1"/>
                      <a:pPr/>
                      <a:t>[NOM DE CATÉGORIE]</a:t>
                    </a:fld>
                    <a:r>
                      <a:rPr lang="en-US" sz="900" baseline="0" dirty="0"/>
                      <a:t>
</a:t>
                    </a:r>
                    <a:fld id="{5AE4670B-D628-4E4F-BECD-6E137031A985}" type="PERCENTAGE">
                      <a:rPr lang="en-US" sz="900" b="1" baseline="0"/>
                      <a:pPr/>
                      <a:t>[POURCENTAGE]</a:t>
                    </a:fld>
                    <a:endParaRPr lang="en-US" sz="900" baseline="0" dirty="0"/>
                  </a:p>
                </c:rich>
              </c:tx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50245440350210402"/>
                      <c:h val="0.17035420796387385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2-FE1F-4219-8B18-61E285D73B37}"/>
                </c:ext>
              </c:extLst>
            </c:dLbl>
            <c:dLbl>
              <c:idx val="56"/>
              <c:layout>
                <c:manualLayout>
                  <c:x val="-5.7239582173322347E-2"/>
                  <c:y val="-2.6341833979700816E-2"/>
                </c:manualLayout>
              </c:layout>
              <c:tx>
                <c:rich>
                  <a:bodyPr/>
                  <a:lstStyle/>
                  <a:p>
                    <a:fld id="{9EEC70B2-0025-4DE4-BCE5-073E38FB4AF6}" type="CATEGORYNAME">
                      <a:rPr lang="en-US"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NOM DE CATÉGORIE]</a:t>
                    </a:fld>
                    <a:r>
                      <a:rPr lang="en-US" baseline="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
</a:t>
                    </a:r>
                    <a:fld id="{02A33871-BCB4-42F8-83CF-9A3876D23DFA}" type="PERCENTAGE">
                      <a:rPr lang="en-US" baseline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/>
                      <a:t>[POURCENTAGE]</a:t>
                    </a:fld>
                    <a:endParaRPr lang="en-US" baseline="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3-FE1F-4219-8B18-61E285D73B3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50"/>
                </a:pPr>
                <a:endParaRPr lang="fr-FR"/>
              </a:p>
            </c:txPr>
            <c:dLblPos val="bestFit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NF54'!$I$3:$I$59</c:f>
              <c:strCache>
                <c:ptCount val="57"/>
                <c:pt idx="0">
                  <c:v>PFD1235w/MAL7P1.1</c:v>
                </c:pt>
                <c:pt idx="1">
                  <c:v>PF11_0521</c:v>
                </c:pt>
                <c:pt idx="2">
                  <c:v>PF13_0003</c:v>
                </c:pt>
                <c:pt idx="3">
                  <c:v>PF08_0141</c:v>
                </c:pt>
                <c:pt idx="4">
                  <c:v>PFD0020c</c:v>
                </c:pt>
                <c:pt idx="5">
                  <c:v>PFA0015c/PFI1820w/MAL6P1.314</c:v>
                </c:pt>
                <c:pt idx="6">
                  <c:v>PFA0015c</c:v>
                </c:pt>
                <c:pt idx="7">
                  <c:v>PF08_0140</c:v>
                </c:pt>
                <c:pt idx="8">
                  <c:v>MAL6P1.316</c:v>
                </c:pt>
                <c:pt idx="9">
                  <c:v>PFL0020w</c:v>
                </c:pt>
                <c:pt idx="10">
                  <c:v>MAL6P1.4</c:v>
                </c:pt>
                <c:pt idx="11">
                  <c:v>PF11_0007</c:v>
                </c:pt>
                <c:pt idx="12">
                  <c:v>PF08_0142</c:v>
                </c:pt>
                <c:pt idx="13">
                  <c:v>PFE0005w</c:v>
                </c:pt>
                <c:pt idx="14">
                  <c:v>PFA0005w</c:v>
                </c:pt>
                <c:pt idx="15">
                  <c:v>PFA0765c</c:v>
                </c:pt>
                <c:pt idx="16">
                  <c:v>PFC1120c/PFC0005w</c:v>
                </c:pt>
                <c:pt idx="17">
                  <c:v>PFD0005w</c:v>
                </c:pt>
                <c:pt idx="18">
                  <c:v>PFI0005w</c:v>
                </c:pt>
                <c:pt idx="19">
                  <c:v>PF13_0364</c:v>
                </c:pt>
                <c:pt idx="20">
                  <c:v>PF07_0139</c:v>
                </c:pt>
                <c:pt idx="21">
                  <c:v>PFB1055c</c:v>
                </c:pt>
                <c:pt idx="22">
                  <c:v>PF10_0406</c:v>
                </c:pt>
                <c:pt idx="23">
                  <c:v>PFL0005w</c:v>
                </c:pt>
                <c:pt idx="24">
                  <c:v>PFB0010w</c:v>
                </c:pt>
                <c:pt idx="25">
                  <c:v>PFL2665c</c:v>
                </c:pt>
                <c:pt idx="26">
                  <c:v>PF13_0001</c:v>
                </c:pt>
                <c:pt idx="27">
                  <c:v>MAL6P1.1</c:v>
                </c:pt>
                <c:pt idx="28">
                  <c:v>PFD1245c</c:v>
                </c:pt>
                <c:pt idx="29">
                  <c:v>PFI1830c</c:v>
                </c:pt>
                <c:pt idx="30">
                  <c:v>PF10_0001</c:v>
                </c:pt>
                <c:pt idx="31">
                  <c:v>PFL0935c</c:v>
                </c:pt>
                <c:pt idx="32">
                  <c:v>PFL1955w/PFL1970w</c:v>
                </c:pt>
                <c:pt idx="33">
                  <c:v>PF08_0106</c:v>
                </c:pt>
                <c:pt idx="34">
                  <c:v>MAL7P1.50</c:v>
                </c:pt>
                <c:pt idx="35">
                  <c:v>PF08_0103</c:v>
                </c:pt>
                <c:pt idx="36">
                  <c:v>MAL7P1.55</c:v>
                </c:pt>
                <c:pt idx="37">
                  <c:v>PF07_0050</c:v>
                </c:pt>
                <c:pt idx="38">
                  <c:v>PFL1950w</c:v>
                </c:pt>
                <c:pt idx="39">
                  <c:v>MAL6P1.252</c:v>
                </c:pt>
                <c:pt idx="40">
                  <c:v>MAL7P1.56</c:v>
                </c:pt>
                <c:pt idx="41">
                  <c:v>PFD0995c/PFD1000c</c:v>
                </c:pt>
                <c:pt idx="42">
                  <c:v>PFD0995c</c:v>
                </c:pt>
                <c:pt idx="43">
                  <c:v>PF07_0049</c:v>
                </c:pt>
                <c:pt idx="44">
                  <c:v>PFD0630c/PFD0635c</c:v>
                </c:pt>
                <c:pt idx="45">
                  <c:v>PFD1005c/PFD1015c</c:v>
                </c:pt>
                <c:pt idx="46">
                  <c:v>PFD1015c</c:v>
                </c:pt>
                <c:pt idx="47">
                  <c:v>PFD0615c</c:v>
                </c:pt>
                <c:pt idx="48">
                  <c:v>PF07_0051</c:v>
                </c:pt>
                <c:pt idx="49">
                  <c:v>PF07_0048</c:v>
                </c:pt>
                <c:pt idx="50">
                  <c:v>PFL1960w</c:v>
                </c:pt>
                <c:pt idx="51">
                  <c:v>PFD0625c</c:v>
                </c:pt>
                <c:pt idx="52">
                  <c:v>PF11_0008</c:v>
                </c:pt>
                <c:pt idx="53">
                  <c:v>PFI1820w</c:v>
                </c:pt>
                <c:pt idx="54">
                  <c:v>PFE1640w</c:v>
                </c:pt>
                <c:pt idx="55">
                  <c:v>PF3D7_1200600</c:v>
                </c:pt>
                <c:pt idx="56">
                  <c:v>other</c:v>
                </c:pt>
              </c:strCache>
            </c:strRef>
          </c:cat>
          <c:val>
            <c:numRef>
              <c:f>'NF54'!$K$3:$K$59</c:f>
              <c:numCache>
                <c:formatCode>General</c:formatCode>
                <c:ptCount val="57"/>
                <c:pt idx="55" formatCode="0.00">
                  <c:v>96.477764620778359</c:v>
                </c:pt>
                <c:pt idx="56" formatCode="0.00">
                  <c:v>3.5222353792216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FE1F-4219-8B18-61E285D73B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  <a:ln>
              <a:solidFill>
                <a:srgbClr val="00B0F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D9969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DDFD-4128-BD2F-65AE6CEDF303}"/>
              </c:ext>
            </c:extLst>
          </c:dPt>
          <c:cat>
            <c:strLit>
              <c:ptCount val="2"/>
              <c:pt idx="0">
                <c:v>DMSO</c:v>
              </c:pt>
              <c:pt idx="1">
                <c:v> Rapa</c:v>
              </c:pt>
            </c:strLit>
          </c:cat>
          <c:val>
            <c:numRef>
              <c:f>Sheet0!$B$2:$B$3</c:f>
              <c:numCache>
                <c:formatCode>General</c:formatCode>
                <c:ptCount val="2"/>
                <c:pt idx="0">
                  <c:v>1581</c:v>
                </c:pt>
                <c:pt idx="1">
                  <c:v>16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DFD-4128-BD2F-65AE6CEDF3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24240656"/>
        <c:axId val="1"/>
      </c:barChart>
      <c:catAx>
        <c:axId val="1624240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/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1624240656"/>
        <c:crosses val="autoZero"/>
        <c:crossBetween val="between"/>
        <c:majorUnit val="400"/>
      </c:valAx>
    </c:plotArea>
    <c:plotVisOnly val="1"/>
    <c:dispBlanksAs val="gap"/>
    <c:showDLblsOverMax val="0"/>
  </c:chart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E11544-99F8-4AF5-A7B6-821E385A3D61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84D92B-A824-4F15-A51B-5220C873CB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3416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23527D8-3E89-4B58-B751-44C867AA5328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600442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26E2322-A956-4C00-8EA5-85265846E2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7DB52A6-5540-4B7B-903A-17A784887A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2AA9024-B289-4D81-B0BA-196E1445EC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107290A-F1FC-4F22-A527-143AAE24E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8110204-6BF9-474D-BA26-F9158098F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7771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17A9C23-CC82-48D4-9B58-5C6FFACE84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5E847FC-656D-4792-908C-FBF8996DF9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C777FD0-97EA-4237-AD04-14C4AAFAC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4FA7605-510F-43DE-B20B-F4499161C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9A6FFFE-FDE3-437A-9FB3-44E21A191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7099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5EA506A-7E3F-43CA-926A-1300C5087D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7966985-69FC-4822-A16B-13F39437D3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D42B1C8-C0BF-496B-B360-A845F759A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9128349-3A17-4548-ACBF-EB7CE31DB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6DE3001-580D-4A22-936A-A02FFEA23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877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1639270-ED7A-4DFC-A4C7-BD24E16313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CC13A4C-6B91-4EF4-B9C6-EDAB5BD7F4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058BD2B-9ACB-42F6-9A52-27EB33D302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53149E5-8DD5-46CC-944E-93E85F94E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F6220CF-B368-45E4-8831-25272A23A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328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DAB19BC-4B4B-4A58-B1DC-7A9C55CD3F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4E4A3F6-D633-4E3A-BD13-D7D343C7C3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B6AA944-6B2F-4C0D-BE0F-42E1AC39F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E27B432-B08E-4636-B762-16A3F2826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DF4C3A1-10E7-4ACB-A89C-FC5306972E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328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9D2D60-6DB1-4DC0-942A-5747F7D826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9603A5F-55ED-4AA2-9495-74DECE284C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D607314-A73E-46D8-919F-21AD662AB5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0ADB4A-45E9-4565-A296-D8BF67D39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369C181-1174-47EB-A5C9-88A79447D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FCE7610-8883-49D7-AB09-30EAB6D02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4897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545157-0C82-4277-9871-E1EFF0E65C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F28508A-0730-4426-A20C-53E1E80A42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FAC5013-6B13-4363-8D58-999858EF8D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CA961A4-C0BB-4D42-91A5-3D08BF4959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C1AB3E64-2D69-4A88-ACDA-4F301BEC42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7D591A2-25FE-4127-9BEE-C4E626CDD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2B8B202-078F-4A85-B1DF-D9B7E0BE6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26E067F-BF89-453C-A77C-24AA35785C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6419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6019E0-3D76-4BDD-81AB-D41DED1482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3720131-AF3F-461E-B554-B2CB0DC34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78B204E-C92C-48C9-8223-2E5E307D9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CFDCD88-316F-4BC7-B37E-0B7EA6476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0605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846BE63-63BB-4D01-986E-1670D9FD50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69DE9A0-03FB-429F-91EC-4EB7950C8B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7E9BD1C-0D69-4141-986C-8E54745AC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1700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079CA89-F02A-4812-8C38-DE2A755CF5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02C37C4-99C4-49AB-AD40-80864D98C3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B67BD28-7F9A-4F5F-9F25-E8BB91D5C5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CFDABCB-56C4-49C7-9D81-7D0741C11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9FF01CA-DBF1-4778-84AE-11D692765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CF66F8B-4FE1-4596-8C6D-E4308DC9A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8735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92DE56-394C-45FC-91A7-4C4D2CBEBF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6676A193-F8FC-436A-8024-4FB70325C0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58BBCB4-F5FF-425A-B6DD-6140F5D3EC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E723662-298D-4575-8AF0-62E0C18A08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02F8BD4-6D42-4C4D-BABA-988DBF38F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9999CCF-E8CB-40E7-AA2D-F2145777D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7754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56DC8F5-9D6C-43EA-B898-62F777D1A9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FC6C4CF-3CD0-4C37-B694-775DF1EF26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E28FC6F-18BA-4382-B629-0CC9DE926D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F27D9-F44B-48D1-8840-34244B1DF002}" type="datetimeFigureOut">
              <a:rPr lang="fr-FR" smtClean="0"/>
              <a:t>19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BA6BFE9-6D43-48E8-8C9E-CF360C41AA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08AD4D8-032D-4345-8B3A-B30220B60F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F374A-AD7C-4FA1-B142-23C5FC8B357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18960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>
            <a:extLst>
              <a:ext uri="{FF2B5EF4-FFF2-40B4-BE49-F238E27FC236}">
                <a16:creationId xmlns:a16="http://schemas.microsoft.com/office/drawing/2014/main" id="{EEF6491A-FC1C-4C2C-AB01-37CF40742F8E}"/>
              </a:ext>
            </a:extLst>
          </p:cNvPr>
          <p:cNvGrpSpPr/>
          <p:nvPr/>
        </p:nvGrpSpPr>
        <p:grpSpPr>
          <a:xfrm>
            <a:off x="5886080" y="1810034"/>
            <a:ext cx="1736429" cy="57689"/>
            <a:chOff x="4616589" y="2092176"/>
            <a:chExt cx="1837183" cy="310540"/>
          </a:xfrm>
        </p:grpSpPr>
        <p:cxnSp>
          <p:nvCxnSpPr>
            <p:cNvPr id="4" name="Connecteur droit 3">
              <a:extLst>
                <a:ext uri="{FF2B5EF4-FFF2-40B4-BE49-F238E27FC236}">
                  <a16:creationId xmlns:a16="http://schemas.microsoft.com/office/drawing/2014/main" id="{0B8FC598-7FBC-484A-B03B-CBA6E75528CC}"/>
                </a:ext>
              </a:extLst>
            </p:cNvPr>
            <p:cNvCxnSpPr/>
            <p:nvPr/>
          </p:nvCxnSpPr>
          <p:spPr>
            <a:xfrm flipV="1">
              <a:off x="4616589" y="2092176"/>
              <a:ext cx="0" cy="3105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Connecteur droit 4">
              <a:extLst>
                <a:ext uri="{FF2B5EF4-FFF2-40B4-BE49-F238E27FC236}">
                  <a16:creationId xmlns:a16="http://schemas.microsoft.com/office/drawing/2014/main" id="{641A33BB-DFA0-4D82-A2D5-F2A3340FCD57}"/>
                </a:ext>
              </a:extLst>
            </p:cNvPr>
            <p:cNvCxnSpPr/>
            <p:nvPr/>
          </p:nvCxnSpPr>
          <p:spPr>
            <a:xfrm flipV="1">
              <a:off x="6453772" y="2092176"/>
              <a:ext cx="0" cy="3105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Connecteur droit 5">
              <a:extLst>
                <a:ext uri="{FF2B5EF4-FFF2-40B4-BE49-F238E27FC236}">
                  <a16:creationId xmlns:a16="http://schemas.microsoft.com/office/drawing/2014/main" id="{A0FFC19C-CC44-4686-81FA-218222129941}"/>
                </a:ext>
              </a:extLst>
            </p:cNvPr>
            <p:cNvCxnSpPr>
              <a:cxnSpLocks/>
            </p:cNvCxnSpPr>
            <p:nvPr/>
          </p:nvCxnSpPr>
          <p:spPr>
            <a:xfrm>
              <a:off x="4616589" y="2092176"/>
              <a:ext cx="183718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ZoneTexte 6">
            <a:extLst>
              <a:ext uri="{FF2B5EF4-FFF2-40B4-BE49-F238E27FC236}">
                <a16:creationId xmlns:a16="http://schemas.microsoft.com/office/drawing/2014/main" id="{E44EB449-DDFA-4FC6-B55E-7BEE027D8B39}"/>
              </a:ext>
            </a:extLst>
          </p:cNvPr>
          <p:cNvSpPr txBox="1"/>
          <p:nvPr/>
        </p:nvSpPr>
        <p:spPr>
          <a:xfrm>
            <a:off x="6515122" y="1623398"/>
            <a:ext cx="14735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*** 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B26BDF5-1BFD-4E2C-BA36-7E92A4DD169E}"/>
              </a:ext>
            </a:extLst>
          </p:cNvPr>
          <p:cNvSpPr txBox="1"/>
          <p:nvPr/>
        </p:nvSpPr>
        <p:spPr>
          <a:xfrm>
            <a:off x="4972015" y="943761"/>
            <a:ext cx="31013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fr-FR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figure 1</a:t>
            </a:r>
            <a:endParaRPr kumimoji="0" lang="fr-FR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1" name="Graphique 10">
            <a:extLst>
              <a:ext uri="{FF2B5EF4-FFF2-40B4-BE49-F238E27FC236}">
                <a16:creationId xmlns:a16="http://schemas.microsoft.com/office/drawing/2014/main" id="{97E966DF-7CBF-87DC-46F3-887913C767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5574062"/>
              </p:ext>
            </p:extLst>
          </p:nvPr>
        </p:nvGraphicFramePr>
        <p:xfrm>
          <a:off x="4460341" y="1867723"/>
          <a:ext cx="4109562" cy="25925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544974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EA12E1F4-1AF5-492A-8EA3-D02F07553D72}"/>
              </a:ext>
            </a:extLst>
          </p:cNvPr>
          <p:cNvSpPr txBox="1"/>
          <p:nvPr/>
        </p:nvSpPr>
        <p:spPr>
          <a:xfrm>
            <a:off x="1293708" y="1430835"/>
            <a:ext cx="41944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    2    3    M  1    2   3    M    1    2   3   M   4   5    6   7   M 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463BDBC8-9267-4058-809D-45E736C490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98" t="33773" r="7755"/>
          <a:stretch/>
        </p:blipFill>
        <p:spPr>
          <a:xfrm>
            <a:off x="1114637" y="1619076"/>
            <a:ext cx="3804496" cy="1977222"/>
          </a:xfrm>
          <a:prstGeom prst="rect">
            <a:avLst/>
          </a:prstGeom>
        </p:spPr>
      </p:pic>
      <p:sp>
        <p:nvSpPr>
          <p:cNvPr id="7" name="Accolade fermante 6">
            <a:extLst>
              <a:ext uri="{FF2B5EF4-FFF2-40B4-BE49-F238E27FC236}">
                <a16:creationId xmlns:a16="http://schemas.microsoft.com/office/drawing/2014/main" id="{ED73DB1C-C120-4DB5-BFD4-0A5707C913FA}"/>
              </a:ext>
            </a:extLst>
          </p:cNvPr>
          <p:cNvSpPr/>
          <p:nvPr/>
        </p:nvSpPr>
        <p:spPr>
          <a:xfrm rot="5400000">
            <a:off x="1560704" y="3368345"/>
            <a:ext cx="179071" cy="713065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Accolade fermante 7">
            <a:extLst>
              <a:ext uri="{FF2B5EF4-FFF2-40B4-BE49-F238E27FC236}">
                <a16:creationId xmlns:a16="http://schemas.microsoft.com/office/drawing/2014/main" id="{E9421444-EEB8-4161-8EC5-EC80A78EFB71}"/>
              </a:ext>
            </a:extLst>
          </p:cNvPr>
          <p:cNvSpPr/>
          <p:nvPr/>
        </p:nvSpPr>
        <p:spPr>
          <a:xfrm rot="5400000">
            <a:off x="2367445" y="3368344"/>
            <a:ext cx="179071" cy="713065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Accolade fermante 8">
            <a:extLst>
              <a:ext uri="{FF2B5EF4-FFF2-40B4-BE49-F238E27FC236}">
                <a16:creationId xmlns:a16="http://schemas.microsoft.com/office/drawing/2014/main" id="{DF92C705-8B31-4D7A-ACE0-5B5BE086029F}"/>
              </a:ext>
            </a:extLst>
          </p:cNvPr>
          <p:cNvSpPr/>
          <p:nvPr/>
        </p:nvSpPr>
        <p:spPr>
          <a:xfrm rot="5400000">
            <a:off x="3174186" y="3368344"/>
            <a:ext cx="179071" cy="713065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Accolade fermante 9">
            <a:extLst>
              <a:ext uri="{FF2B5EF4-FFF2-40B4-BE49-F238E27FC236}">
                <a16:creationId xmlns:a16="http://schemas.microsoft.com/office/drawing/2014/main" id="{28EAD983-25B7-4C29-B64A-569638633D30}"/>
              </a:ext>
            </a:extLst>
          </p:cNvPr>
          <p:cNvSpPr/>
          <p:nvPr/>
        </p:nvSpPr>
        <p:spPr>
          <a:xfrm rot="5400000">
            <a:off x="4145911" y="3368345"/>
            <a:ext cx="179071" cy="713065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E4D7C802-0980-4BD8-915A-5FCF7C6749A4}"/>
              </a:ext>
            </a:extLst>
          </p:cNvPr>
          <p:cNvSpPr txBox="1"/>
          <p:nvPr/>
        </p:nvSpPr>
        <p:spPr>
          <a:xfrm>
            <a:off x="1361143" y="3801054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’integ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F106E39-1E48-409F-B428-4F90360CE988}"/>
              </a:ext>
            </a:extLst>
          </p:cNvPr>
          <p:cNvSpPr txBox="1"/>
          <p:nvPr/>
        </p:nvSpPr>
        <p:spPr>
          <a:xfrm>
            <a:off x="2113281" y="3801054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’integr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8DC8834D-C590-4752-B42C-DA280D7177F1}"/>
              </a:ext>
            </a:extLst>
          </p:cNvPr>
          <p:cNvSpPr txBox="1"/>
          <p:nvPr/>
        </p:nvSpPr>
        <p:spPr>
          <a:xfrm>
            <a:off x="2907189" y="3801054"/>
            <a:ext cx="811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T locus 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84F831B2-6BEB-4A88-A0B0-0BD2F74FB004}"/>
              </a:ext>
            </a:extLst>
          </p:cNvPr>
          <p:cNvSpPr txBox="1"/>
          <p:nvPr/>
        </p:nvSpPr>
        <p:spPr>
          <a:xfrm>
            <a:off x="3878914" y="3801054"/>
            <a:ext cx="7505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xcision 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C7D7A71E-A8FB-48D0-B634-1D7E6E30809D}"/>
              </a:ext>
            </a:extLst>
          </p:cNvPr>
          <p:cNvSpPr txBox="1"/>
          <p:nvPr/>
        </p:nvSpPr>
        <p:spPr>
          <a:xfrm>
            <a:off x="5692068" y="1272522"/>
            <a:ext cx="1733167" cy="3647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: NF54WT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DNA</a:t>
            </a: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: HAFIKK1 DMSO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DNA</a:t>
            </a: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: H2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W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: NF54WT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DNA</a:t>
            </a: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: HAFIKK1 DMSO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DNA</a:t>
            </a: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: H2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W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: NF54WT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DNA</a:t>
            </a: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: HAFIKK1 DMSO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DNA</a:t>
            </a: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: H2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W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: HAFIKK1DMSO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DNA</a:t>
            </a: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:HAFIKK1 Rapa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DNA</a:t>
            </a: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: NF54WT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DNA</a:t>
            </a: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: H2O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MW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6" name="Accolade fermante 15">
            <a:extLst>
              <a:ext uri="{FF2B5EF4-FFF2-40B4-BE49-F238E27FC236}">
                <a16:creationId xmlns:a16="http://schemas.microsoft.com/office/drawing/2014/main" id="{E5E1B2EA-E542-4383-8B93-88DA120F7D94}"/>
              </a:ext>
            </a:extLst>
          </p:cNvPr>
          <p:cNvSpPr/>
          <p:nvPr/>
        </p:nvSpPr>
        <p:spPr>
          <a:xfrm>
            <a:off x="7454232" y="1345937"/>
            <a:ext cx="179071" cy="640304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7" name="Accolade fermante 16">
            <a:extLst>
              <a:ext uri="{FF2B5EF4-FFF2-40B4-BE49-F238E27FC236}">
                <a16:creationId xmlns:a16="http://schemas.microsoft.com/office/drawing/2014/main" id="{D62BFEAE-8EFC-4339-B43F-64E167EFEDC7}"/>
              </a:ext>
            </a:extLst>
          </p:cNvPr>
          <p:cNvSpPr/>
          <p:nvPr/>
        </p:nvSpPr>
        <p:spPr>
          <a:xfrm>
            <a:off x="7454232" y="2025229"/>
            <a:ext cx="163000" cy="579603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818DFF45-BD01-4197-83D3-102264301485}"/>
              </a:ext>
            </a:extLst>
          </p:cNvPr>
          <p:cNvSpPr txBox="1"/>
          <p:nvPr/>
        </p:nvSpPr>
        <p:spPr>
          <a:xfrm>
            <a:off x="7660456" y="1475131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’integr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772B4781-D890-44E4-8163-1496D63BDD79}"/>
              </a:ext>
            </a:extLst>
          </p:cNvPr>
          <p:cNvSpPr txBox="1"/>
          <p:nvPr/>
        </p:nvSpPr>
        <p:spPr>
          <a:xfrm>
            <a:off x="7641955" y="2186083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’integr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09A3C2D0-14DE-42B7-9B9C-FBEE116DE103}"/>
              </a:ext>
            </a:extLst>
          </p:cNvPr>
          <p:cNvSpPr txBox="1"/>
          <p:nvPr/>
        </p:nvSpPr>
        <p:spPr>
          <a:xfrm>
            <a:off x="7658026" y="2782608"/>
            <a:ext cx="866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T locus </a:t>
            </a:r>
          </a:p>
        </p:txBody>
      </p:sp>
      <p:sp>
        <p:nvSpPr>
          <p:cNvPr id="21" name="Accolade fermante 20">
            <a:extLst>
              <a:ext uri="{FF2B5EF4-FFF2-40B4-BE49-F238E27FC236}">
                <a16:creationId xmlns:a16="http://schemas.microsoft.com/office/drawing/2014/main" id="{2C771295-ED5E-4330-A57B-542D63F526E9}"/>
              </a:ext>
            </a:extLst>
          </p:cNvPr>
          <p:cNvSpPr/>
          <p:nvPr/>
        </p:nvSpPr>
        <p:spPr>
          <a:xfrm>
            <a:off x="7454232" y="2643820"/>
            <a:ext cx="187724" cy="582851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2" name="Accolade fermante 21">
            <a:extLst>
              <a:ext uri="{FF2B5EF4-FFF2-40B4-BE49-F238E27FC236}">
                <a16:creationId xmlns:a16="http://schemas.microsoft.com/office/drawing/2014/main" id="{7BC3566D-9D73-4AA5-9CF7-00F004E6CF77}"/>
              </a:ext>
            </a:extLst>
          </p:cNvPr>
          <p:cNvSpPr/>
          <p:nvPr/>
        </p:nvSpPr>
        <p:spPr>
          <a:xfrm>
            <a:off x="7454232" y="3283751"/>
            <a:ext cx="179071" cy="760690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C5F08F9F-0C79-4AF0-B0FC-2E847BFD16EF}"/>
              </a:ext>
            </a:extLst>
          </p:cNvPr>
          <p:cNvSpPr txBox="1"/>
          <p:nvPr/>
        </p:nvSpPr>
        <p:spPr>
          <a:xfrm>
            <a:off x="7616158" y="3496841"/>
            <a:ext cx="798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xcision 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B31AC0BC-2E8A-46FA-B522-B8B192E25C30}"/>
              </a:ext>
            </a:extLst>
          </p:cNvPr>
          <p:cNvSpPr txBox="1"/>
          <p:nvPr/>
        </p:nvSpPr>
        <p:spPr>
          <a:xfrm>
            <a:off x="7517881" y="1678070"/>
            <a:ext cx="352467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rimers</a:t>
            </a: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HAFIKK1 5’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t</a:t>
            </a: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Fo + HAFIKK1 5’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t</a:t>
            </a: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R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6CE8355F-D3D6-4953-92EE-6AF2E30B7C39}"/>
              </a:ext>
            </a:extLst>
          </p:cNvPr>
          <p:cNvSpPr txBox="1"/>
          <p:nvPr/>
        </p:nvSpPr>
        <p:spPr>
          <a:xfrm>
            <a:off x="7616158" y="2399938"/>
            <a:ext cx="352101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rimers</a:t>
            </a: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HAFIKK1 3’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t</a:t>
            </a: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Fo + HAFIKK1 3’ </a:t>
            </a:r>
            <a:r>
              <a:rPr kumimoji="0" lang="fr-FR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t</a:t>
            </a: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R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8B2FD185-B089-4DCA-B609-0D9AB433FF25}"/>
              </a:ext>
            </a:extLst>
          </p:cNvPr>
          <p:cNvSpPr txBox="1"/>
          <p:nvPr/>
        </p:nvSpPr>
        <p:spPr>
          <a:xfrm>
            <a:off x="7556128" y="2936496"/>
            <a:ext cx="32703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rimers</a:t>
            </a:r>
            <a:r>
              <a:rPr kumimoji="0" lang="fr-F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FIKK1 WT Fo +WT </a:t>
            </a:r>
            <a:r>
              <a:rPr kumimoji="0" lang="fr-F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v</a:t>
            </a:r>
            <a:endParaRPr kumimoji="0" lang="fr-FR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E743AFFC-E8F1-4479-85AC-C403762FE931}"/>
              </a:ext>
            </a:extLst>
          </p:cNvPr>
          <p:cNvSpPr txBox="1"/>
          <p:nvPr/>
        </p:nvSpPr>
        <p:spPr>
          <a:xfrm>
            <a:off x="7547040" y="3720921"/>
            <a:ext cx="32392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rimers</a:t>
            </a:r>
            <a:r>
              <a:rPr kumimoji="0" lang="fr-F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HAFIKK1 excision Fo + Excision </a:t>
            </a:r>
            <a:r>
              <a:rPr kumimoji="0" lang="fr-F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v</a:t>
            </a:r>
            <a:endParaRPr kumimoji="0" lang="fr-FR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0854DDA1-77CB-4ECE-9BAF-E2EC4E415F64}"/>
              </a:ext>
            </a:extLst>
          </p:cNvPr>
          <p:cNvSpPr txBox="1"/>
          <p:nvPr/>
        </p:nvSpPr>
        <p:spPr>
          <a:xfrm>
            <a:off x="213576" y="146770"/>
            <a:ext cx="103096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fr-FR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figure 2</a:t>
            </a:r>
            <a:endParaRPr kumimoji="0" lang="fr-FR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31196A75-68DB-46E0-9E4D-A31F05517D17}"/>
              </a:ext>
            </a:extLst>
          </p:cNvPr>
          <p:cNvSpPr/>
          <p:nvPr/>
        </p:nvSpPr>
        <p:spPr>
          <a:xfrm>
            <a:off x="685800" y="1283515"/>
            <a:ext cx="4639851" cy="28386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409062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624BE85F-77F4-F5CE-27B2-BBC8607E53FF}"/>
              </a:ext>
            </a:extLst>
          </p:cNvPr>
          <p:cNvGrpSpPr/>
          <p:nvPr/>
        </p:nvGrpSpPr>
        <p:grpSpPr>
          <a:xfrm>
            <a:off x="5330212" y="1607132"/>
            <a:ext cx="2662022" cy="2497026"/>
            <a:chOff x="6593890" y="2497807"/>
            <a:chExt cx="2359055" cy="2073023"/>
          </a:xfrm>
        </p:grpSpPr>
        <p:graphicFrame>
          <p:nvGraphicFramePr>
            <p:cNvPr id="3" name="Graphique 2">
              <a:extLst>
                <a:ext uri="{FF2B5EF4-FFF2-40B4-BE49-F238E27FC236}">
                  <a16:creationId xmlns:a16="http://schemas.microsoft.com/office/drawing/2014/main" id="{AEF15636-3E74-C428-F1DE-D4CF591C081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4725819"/>
                </p:ext>
              </p:extLst>
            </p:nvPr>
          </p:nvGraphicFramePr>
          <p:xfrm>
            <a:off x="6593890" y="2497807"/>
            <a:ext cx="2359055" cy="19936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E136D7C9-0947-72C9-22F9-003CEEC51A61}"/>
                </a:ext>
              </a:extLst>
            </p:cNvPr>
            <p:cNvSpPr txBox="1"/>
            <p:nvPr/>
          </p:nvSpPr>
          <p:spPr>
            <a:xfrm>
              <a:off x="8116448" y="4309220"/>
              <a:ext cx="670453" cy="261609"/>
            </a:xfrm>
            <a:prstGeom prst="rect">
              <a:avLst/>
            </a:prstGeom>
            <a:solidFill>
              <a:sysClr val="window" lastClr="FFFFFF"/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APA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59257D85-E7F7-0FDD-1FD6-0F99F96BF34D}"/>
                </a:ext>
              </a:extLst>
            </p:cNvPr>
            <p:cNvSpPr txBox="1"/>
            <p:nvPr/>
          </p:nvSpPr>
          <p:spPr>
            <a:xfrm>
              <a:off x="7178829" y="4309221"/>
              <a:ext cx="670453" cy="26160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105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</p:grpSp>
      <p:sp>
        <p:nvSpPr>
          <p:cNvPr id="6" name="ZoneTexte 5">
            <a:extLst>
              <a:ext uri="{FF2B5EF4-FFF2-40B4-BE49-F238E27FC236}">
                <a16:creationId xmlns:a16="http://schemas.microsoft.com/office/drawing/2014/main" id="{32954A28-436C-9250-ECAB-405FFB00EC19}"/>
              </a:ext>
            </a:extLst>
          </p:cNvPr>
          <p:cNvSpPr txBox="1"/>
          <p:nvPr/>
        </p:nvSpPr>
        <p:spPr>
          <a:xfrm>
            <a:off x="3830319" y="3792054"/>
            <a:ext cx="16344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Fluorescenc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848705A-8E39-5776-3BE1-D4FCE59EDA90}"/>
              </a:ext>
            </a:extLst>
          </p:cNvPr>
          <p:cNvSpPr txBox="1"/>
          <p:nvPr/>
        </p:nvSpPr>
        <p:spPr>
          <a:xfrm rot="16200000">
            <a:off x="3027567" y="2755357"/>
            <a:ext cx="12702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 count</a:t>
            </a:r>
          </a:p>
        </p:txBody>
      </p:sp>
      <p:grpSp>
        <p:nvGrpSpPr>
          <p:cNvPr id="8" name="Groupe 7">
            <a:extLst>
              <a:ext uri="{FF2B5EF4-FFF2-40B4-BE49-F238E27FC236}">
                <a16:creationId xmlns:a16="http://schemas.microsoft.com/office/drawing/2014/main" id="{97916D55-963C-AB16-4E95-DCE3807EB67B}"/>
              </a:ext>
            </a:extLst>
          </p:cNvPr>
          <p:cNvGrpSpPr/>
          <p:nvPr/>
        </p:nvGrpSpPr>
        <p:grpSpPr>
          <a:xfrm>
            <a:off x="3339046" y="1875701"/>
            <a:ext cx="1991166" cy="1963880"/>
            <a:chOff x="4493513" y="2597318"/>
            <a:chExt cx="1959035" cy="1766033"/>
          </a:xfrm>
        </p:grpSpPr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60D5EE5B-A018-5571-DF4F-C2526E2F00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617" r="2011" b="2403"/>
            <a:stretch>
              <a:fillRect/>
            </a:stretch>
          </p:blipFill>
          <p:spPr>
            <a:xfrm>
              <a:off x="4493513" y="2597318"/>
              <a:ext cx="1935818" cy="1766033"/>
            </a:xfrm>
            <a:prstGeom prst="rect">
              <a:avLst/>
            </a:prstGeom>
          </p:spPr>
        </p:pic>
        <p:cxnSp>
          <p:nvCxnSpPr>
            <p:cNvPr id="10" name="Connecteur droit 9">
              <a:extLst>
                <a:ext uri="{FF2B5EF4-FFF2-40B4-BE49-F238E27FC236}">
                  <a16:creationId xmlns:a16="http://schemas.microsoft.com/office/drawing/2014/main" id="{C3205ED6-22BE-9EAE-0755-A7BAE416D105}"/>
                </a:ext>
              </a:extLst>
            </p:cNvPr>
            <p:cNvCxnSpPr>
              <a:cxnSpLocks/>
            </p:cNvCxnSpPr>
            <p:nvPr/>
          </p:nvCxnSpPr>
          <p:spPr>
            <a:xfrm>
              <a:off x="4612404" y="2608678"/>
              <a:ext cx="1840144" cy="0"/>
            </a:xfrm>
            <a:prstGeom prst="line">
              <a:avLst/>
            </a:prstGeom>
            <a:ln w="762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ZoneTexte 10">
            <a:extLst>
              <a:ext uri="{FF2B5EF4-FFF2-40B4-BE49-F238E27FC236}">
                <a16:creationId xmlns:a16="http://schemas.microsoft.com/office/drawing/2014/main" id="{B8B02D63-E720-C3EF-1271-A27416530D44}"/>
              </a:ext>
            </a:extLst>
          </p:cNvPr>
          <p:cNvSpPr txBox="1"/>
          <p:nvPr/>
        </p:nvSpPr>
        <p:spPr>
          <a:xfrm>
            <a:off x="693636" y="312005"/>
            <a:ext cx="103096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fr-FR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figure 3</a:t>
            </a:r>
            <a:endParaRPr kumimoji="0" lang="fr-FR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00176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00000000-0008-0000-04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0895958"/>
              </p:ext>
            </p:extLst>
          </p:nvPr>
        </p:nvGraphicFramePr>
        <p:xfrm>
          <a:off x="5607403" y="1139333"/>
          <a:ext cx="4061012" cy="25030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00000000-0008-0000-0600-000004000000}"/>
              </a:ext>
            </a:extLst>
          </p:cNvPr>
          <p:cNvGraphicFramePr>
            <a:graphicFrameLocks/>
          </p:cNvGraphicFramePr>
          <p:nvPr/>
        </p:nvGraphicFramePr>
        <p:xfrm>
          <a:off x="5720838" y="3829355"/>
          <a:ext cx="3616889" cy="24220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DF95F558-BFBF-49FF-AFCA-E26655945C6A}"/>
              </a:ext>
            </a:extLst>
          </p:cNvPr>
          <p:cNvSpPr/>
          <p:nvPr/>
        </p:nvSpPr>
        <p:spPr>
          <a:xfrm>
            <a:off x="5080238" y="206441"/>
            <a:ext cx="218149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fr-FR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figure 4</a:t>
            </a:r>
            <a:endParaRPr kumimoji="0" lang="fr-FR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7" name="Graphique 6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7665581"/>
              </p:ext>
            </p:extLst>
          </p:nvPr>
        </p:nvGraphicFramePr>
        <p:xfrm>
          <a:off x="-7131" y="1064682"/>
          <a:ext cx="2183830" cy="23039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ZoneTexte 7">
            <a:extLst>
              <a:ext uri="{FF2B5EF4-FFF2-40B4-BE49-F238E27FC236}">
                <a16:creationId xmlns:a16="http://schemas.microsoft.com/office/drawing/2014/main" id="{28C9F4B1-AD30-4DBE-A307-CB4110C20333}"/>
              </a:ext>
            </a:extLst>
          </p:cNvPr>
          <p:cNvSpPr txBox="1"/>
          <p:nvPr/>
        </p:nvSpPr>
        <p:spPr>
          <a:xfrm>
            <a:off x="60288" y="72907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5B60E7C8-DD83-4B48-81B1-473E5979C3C6}"/>
              </a:ext>
            </a:extLst>
          </p:cNvPr>
          <p:cNvSpPr txBox="1"/>
          <p:nvPr/>
        </p:nvSpPr>
        <p:spPr>
          <a:xfrm>
            <a:off x="1915565" y="706500"/>
            <a:ext cx="3077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0B8FE736-CB04-4B62-BF55-28D9D7A58F70}"/>
              </a:ext>
            </a:extLst>
          </p:cNvPr>
          <p:cNvSpPr txBox="1"/>
          <p:nvPr/>
        </p:nvSpPr>
        <p:spPr>
          <a:xfrm>
            <a:off x="1874352" y="343160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3" name="Graphique 12">
            <a:extLst>
              <a:ext uri="{FF2B5EF4-FFF2-40B4-BE49-F238E27FC236}">
                <a16:creationId xmlns:a16="http://schemas.microsoft.com/office/drawing/2014/main" id="{FBFBC37C-000F-4CBF-BC06-50E311A81F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0996397"/>
              </p:ext>
            </p:extLst>
          </p:nvPr>
        </p:nvGraphicFramePr>
        <p:xfrm>
          <a:off x="1970226" y="3962188"/>
          <a:ext cx="3127930" cy="22523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4" name="ZoneTexte 13">
            <a:extLst>
              <a:ext uri="{FF2B5EF4-FFF2-40B4-BE49-F238E27FC236}">
                <a16:creationId xmlns:a16="http://schemas.microsoft.com/office/drawing/2014/main" id="{63BBEBD0-8D98-445A-B75A-54C8F2783149}"/>
              </a:ext>
            </a:extLst>
          </p:cNvPr>
          <p:cNvSpPr txBox="1"/>
          <p:nvPr/>
        </p:nvSpPr>
        <p:spPr>
          <a:xfrm>
            <a:off x="4063697" y="5939778"/>
            <a:ext cx="670453" cy="261610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APA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C017299B-0D9A-4844-98C6-D2285EE3354F}"/>
              </a:ext>
            </a:extLst>
          </p:cNvPr>
          <p:cNvSpPr txBox="1"/>
          <p:nvPr/>
        </p:nvSpPr>
        <p:spPr>
          <a:xfrm>
            <a:off x="2802032" y="5939778"/>
            <a:ext cx="67045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63596FF1-9BDD-45C4-95C8-12B554C10AC9}"/>
              </a:ext>
            </a:extLst>
          </p:cNvPr>
          <p:cNvSpPr txBox="1"/>
          <p:nvPr/>
        </p:nvSpPr>
        <p:spPr>
          <a:xfrm>
            <a:off x="6290521" y="3261452"/>
            <a:ext cx="839242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SA DMSO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595469A4-A76B-4F81-8789-85E655FF9CBE}"/>
              </a:ext>
            </a:extLst>
          </p:cNvPr>
          <p:cNvSpPr txBox="1"/>
          <p:nvPr/>
        </p:nvSpPr>
        <p:spPr>
          <a:xfrm>
            <a:off x="7088393" y="3261452"/>
            <a:ext cx="839242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SA RAPA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19E1E103-6C22-498F-89A4-264ABCECF108}"/>
              </a:ext>
            </a:extLst>
          </p:cNvPr>
          <p:cNvSpPr txBox="1"/>
          <p:nvPr/>
        </p:nvSpPr>
        <p:spPr>
          <a:xfrm>
            <a:off x="7852372" y="3261452"/>
            <a:ext cx="839242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SA DMSO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D37A8495-F76B-4C50-9EF6-3E86A57304FA}"/>
              </a:ext>
            </a:extLst>
          </p:cNvPr>
          <p:cNvSpPr txBox="1"/>
          <p:nvPr/>
        </p:nvSpPr>
        <p:spPr>
          <a:xfrm>
            <a:off x="8656882" y="3261452"/>
            <a:ext cx="839242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SA RAPA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5CF5AD1A-AF35-4742-BA9F-9ACBA85338AE}"/>
              </a:ext>
            </a:extLst>
          </p:cNvPr>
          <p:cNvSpPr txBox="1"/>
          <p:nvPr/>
        </p:nvSpPr>
        <p:spPr>
          <a:xfrm>
            <a:off x="6776544" y="5939778"/>
            <a:ext cx="67045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65692C91-F493-48E7-BE2C-4D1310434B41}"/>
              </a:ext>
            </a:extLst>
          </p:cNvPr>
          <p:cNvSpPr txBox="1"/>
          <p:nvPr/>
        </p:nvSpPr>
        <p:spPr>
          <a:xfrm>
            <a:off x="8235960" y="5939778"/>
            <a:ext cx="67045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APA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89C6C8B9-9620-47C4-BF1A-AC93BC174841}"/>
              </a:ext>
            </a:extLst>
          </p:cNvPr>
          <p:cNvSpPr txBox="1"/>
          <p:nvPr/>
        </p:nvSpPr>
        <p:spPr>
          <a:xfrm>
            <a:off x="5323074" y="351657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5EAFB12-47F4-4C57-8236-8901EAF1E0F2}"/>
              </a:ext>
            </a:extLst>
          </p:cNvPr>
          <p:cNvSpPr/>
          <p:nvPr/>
        </p:nvSpPr>
        <p:spPr>
          <a:xfrm>
            <a:off x="5607403" y="1139333"/>
            <a:ext cx="4061012" cy="2503056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1F2C657D-C0A0-41E9-BFE1-1AB7A99C4B8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42326" y="1094476"/>
            <a:ext cx="2580748" cy="2422095"/>
          </a:xfrm>
          <a:prstGeom prst="rect">
            <a:avLst/>
          </a:prstGeom>
        </p:spPr>
      </p:pic>
      <p:sp>
        <p:nvSpPr>
          <p:cNvPr id="25" name="ZoneTexte 24">
            <a:extLst>
              <a:ext uri="{FF2B5EF4-FFF2-40B4-BE49-F238E27FC236}">
                <a16:creationId xmlns:a16="http://schemas.microsoft.com/office/drawing/2014/main" id="{A4B10BE1-2B80-4370-A8DE-E565FBD4DE03}"/>
              </a:ext>
            </a:extLst>
          </p:cNvPr>
          <p:cNvSpPr txBox="1"/>
          <p:nvPr/>
        </p:nvSpPr>
        <p:spPr>
          <a:xfrm rot="16200000">
            <a:off x="2169008" y="2026667"/>
            <a:ext cx="10243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ell</a:t>
            </a:r>
            <a:r>
              <a:rPr kumimoji="0" lang="fr-F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ount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3058034B-23AE-4256-9C43-C85C2213DF6E}"/>
              </a:ext>
            </a:extLst>
          </p:cNvPr>
          <p:cNvSpPr txBox="1"/>
          <p:nvPr/>
        </p:nvSpPr>
        <p:spPr>
          <a:xfrm>
            <a:off x="3337944" y="3393965"/>
            <a:ext cx="14542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luorescence </a:t>
            </a:r>
            <a:r>
              <a:rPr kumimoji="0" lang="fr-FR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tensity</a:t>
            </a:r>
            <a:endParaRPr kumimoji="0" lang="fr-F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4F405AC-F4DE-4177-841C-2DB6403D525B}"/>
              </a:ext>
            </a:extLst>
          </p:cNvPr>
          <p:cNvSpPr/>
          <p:nvPr/>
        </p:nvSpPr>
        <p:spPr>
          <a:xfrm>
            <a:off x="3111481" y="1200576"/>
            <a:ext cx="274680" cy="118716"/>
          </a:xfrm>
          <a:prstGeom prst="rect">
            <a:avLst/>
          </a:prstGeom>
          <a:solidFill>
            <a:srgbClr val="00B0F0"/>
          </a:solidFill>
          <a:ln w="25400" cap="flat" cmpd="sng" algn="ctr">
            <a:solidFill>
              <a:srgbClr val="00B0F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C9D76B62-6A7F-48F1-BBDF-2838D15C71D3}"/>
              </a:ext>
            </a:extLst>
          </p:cNvPr>
          <p:cNvSpPr txBox="1"/>
          <p:nvPr/>
        </p:nvSpPr>
        <p:spPr>
          <a:xfrm>
            <a:off x="3386161" y="1134199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EAC43538-58B5-4A76-BEB4-73E5A86177AF}"/>
              </a:ext>
            </a:extLst>
          </p:cNvPr>
          <p:cNvSpPr/>
          <p:nvPr/>
        </p:nvSpPr>
        <p:spPr>
          <a:xfrm>
            <a:off x="3111481" y="1394926"/>
            <a:ext cx="274680" cy="118716"/>
          </a:xfrm>
          <a:prstGeom prst="rect">
            <a:avLst/>
          </a:prstGeom>
          <a:solidFill>
            <a:srgbClr val="C0504D">
              <a:lumMod val="60000"/>
              <a:lumOff val="40000"/>
            </a:srgbClr>
          </a:solidFill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4A4408EA-1125-43B9-B940-A29ACF750D23}"/>
              </a:ext>
            </a:extLst>
          </p:cNvPr>
          <p:cNvSpPr txBox="1"/>
          <p:nvPr/>
        </p:nvSpPr>
        <p:spPr>
          <a:xfrm>
            <a:off x="3386161" y="1338342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APA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3588C3FD-5E5D-4D2A-8CE5-DD9F72404ABE}"/>
              </a:ext>
            </a:extLst>
          </p:cNvPr>
          <p:cNvSpPr txBox="1"/>
          <p:nvPr/>
        </p:nvSpPr>
        <p:spPr>
          <a:xfrm>
            <a:off x="5462937" y="72907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C8204474-1D21-4D23-84AA-E32F0D5204C3}"/>
              </a:ext>
            </a:extLst>
          </p:cNvPr>
          <p:cNvSpPr txBox="1"/>
          <p:nvPr/>
        </p:nvSpPr>
        <p:spPr>
          <a:xfrm>
            <a:off x="799289" y="3171308"/>
            <a:ext cx="5709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APA</a:t>
            </a:r>
            <a:endParaRPr kumimoji="0" lang="fr-FR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33231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8BC508C9-3443-42F7-A149-E27596A940E5}"/>
              </a:ext>
            </a:extLst>
          </p:cNvPr>
          <p:cNvGrpSpPr/>
          <p:nvPr/>
        </p:nvGrpSpPr>
        <p:grpSpPr>
          <a:xfrm>
            <a:off x="4597488" y="2341867"/>
            <a:ext cx="3443599" cy="1846337"/>
            <a:chOff x="1412929" y="1464043"/>
            <a:chExt cx="3473599" cy="1863495"/>
          </a:xfrm>
        </p:grpSpPr>
        <p:grpSp>
          <p:nvGrpSpPr>
            <p:cNvPr id="3" name="Groupe 27">
              <a:extLst>
                <a:ext uri="{FF2B5EF4-FFF2-40B4-BE49-F238E27FC236}">
                  <a16:creationId xmlns:a16="http://schemas.microsoft.com/office/drawing/2014/main" id="{69FEC61A-3D65-41BE-86DF-0C4BD440044A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467804" y="2575675"/>
              <a:ext cx="3145785" cy="435021"/>
              <a:chOff x="2626673" y="2966308"/>
              <a:chExt cx="3066768" cy="266700"/>
            </a:xfrm>
          </p:grpSpPr>
          <p:sp>
            <p:nvSpPr>
              <p:cNvPr id="23" name="Rectangle 5">
                <a:extLst>
                  <a:ext uri="{FF2B5EF4-FFF2-40B4-BE49-F238E27FC236}">
                    <a16:creationId xmlns:a16="http://schemas.microsoft.com/office/drawing/2014/main" id="{86C5655D-F93D-477D-8E6D-85CFF001F9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6673" y="3034910"/>
                <a:ext cx="2940488" cy="13301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fr-FR" sz="8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IR1</a:t>
                </a:r>
              </a:p>
            </p:txBody>
          </p:sp>
          <p:sp>
            <p:nvSpPr>
              <p:cNvPr id="24" name="Rectangle 6">
                <a:extLst>
                  <a:ext uri="{FF2B5EF4-FFF2-40B4-BE49-F238E27FC236}">
                    <a16:creationId xmlns:a16="http://schemas.microsoft.com/office/drawing/2014/main" id="{F6ACF754-2392-423C-902C-98B259CD3C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6856" y="3009433"/>
                <a:ext cx="395253" cy="141122"/>
              </a:xfrm>
              <a:prstGeom prst="rect">
                <a:avLst/>
              </a:prstGeom>
              <a:noFill/>
              <a:ln>
                <a:noFill/>
              </a:ln>
              <a:effectLst>
                <a:outerShdw dist="107763" dir="2700000" algn="ctr" rotWithShape="0">
                  <a:schemeClr val="bg2"/>
                </a:outerShdw>
              </a:effectLst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GB" altLang="fr-FR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8">
                <a:extLst>
                  <a:ext uri="{FF2B5EF4-FFF2-40B4-BE49-F238E27FC236}">
                    <a16:creationId xmlns:a16="http://schemas.microsoft.com/office/drawing/2014/main" id="{77A8C783-6C09-490C-B4FA-21B21E0CA6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85473" y="3021871"/>
                <a:ext cx="309563" cy="1555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GB" altLang="fr-FR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6" name="Rectangle 9">
                <a:extLst>
                  <a:ext uri="{FF2B5EF4-FFF2-40B4-BE49-F238E27FC236}">
                    <a16:creationId xmlns:a16="http://schemas.microsoft.com/office/drawing/2014/main" id="{1D0FB712-6713-4021-A4FF-1EC2A8FAEF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38121" y="2966308"/>
                <a:ext cx="673100" cy="266700"/>
              </a:xfrm>
              <a:prstGeom prst="rect">
                <a:avLst/>
              </a:prstGeom>
              <a:gradFill rotWithShape="0">
                <a:gsLst>
                  <a:gs pos="0">
                    <a:srgbClr val="ADADAD"/>
                  </a:gs>
                  <a:gs pos="50000">
                    <a:srgbClr val="E1E1E1"/>
                  </a:gs>
                  <a:gs pos="100000">
                    <a:srgbClr val="ADADAD"/>
                  </a:gs>
                </a:gsLst>
                <a:lin ang="5400000" scaled="1"/>
              </a:gra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GB" altLang="fr-FR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angle 10">
                <a:extLst>
                  <a:ext uri="{FF2B5EF4-FFF2-40B4-BE49-F238E27FC236}">
                    <a16:creationId xmlns:a16="http://schemas.microsoft.com/office/drawing/2014/main" id="{44B2C7B3-4CEF-403B-8258-362B69CEA3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6386" y="3013933"/>
                <a:ext cx="427037" cy="1412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GB" altLang="fr-FR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8" name="Rectangle 13">
                <a:extLst>
                  <a:ext uri="{FF2B5EF4-FFF2-40B4-BE49-F238E27FC236}">
                    <a16:creationId xmlns:a16="http://schemas.microsoft.com/office/drawing/2014/main" id="{30DFDF1A-3597-496C-B18A-4917E4E4D8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2048" y="2966308"/>
                <a:ext cx="577850" cy="258763"/>
              </a:xfrm>
              <a:prstGeom prst="rect">
                <a:avLst/>
              </a:prstGeom>
              <a:gradFill rotWithShape="0">
                <a:gsLst>
                  <a:gs pos="0">
                    <a:srgbClr val="ADADAD"/>
                  </a:gs>
                  <a:gs pos="50000">
                    <a:srgbClr val="E1E1E1"/>
                  </a:gs>
                  <a:gs pos="100000">
                    <a:srgbClr val="ADADAD"/>
                  </a:gs>
                </a:gsLst>
                <a:lin ang="5400000" scaled="1"/>
              </a:gra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GB" altLang="fr-FR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19">
                <a:extLst>
                  <a:ext uri="{FF2B5EF4-FFF2-40B4-BE49-F238E27FC236}">
                    <a16:creationId xmlns:a16="http://schemas.microsoft.com/office/drawing/2014/main" id="{24C11F9A-59A2-4C60-9373-4212E11B32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23511" y="2966308"/>
                <a:ext cx="692150" cy="263525"/>
              </a:xfrm>
              <a:prstGeom prst="rect">
                <a:avLst/>
              </a:prstGeom>
              <a:gradFill rotWithShape="0">
                <a:gsLst>
                  <a:gs pos="0">
                    <a:srgbClr val="ADADAD"/>
                  </a:gs>
                  <a:gs pos="50000">
                    <a:srgbClr val="E1E1E1"/>
                  </a:gs>
                  <a:gs pos="100000">
                    <a:srgbClr val="ADADAD"/>
                  </a:gs>
                </a:gsLst>
                <a:lin ang="5400000" scaled="1"/>
              </a:gra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GB" altLang="fr-FR" sz="8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angle 23">
                <a:extLst>
                  <a:ext uri="{FF2B5EF4-FFF2-40B4-BE49-F238E27FC236}">
                    <a16:creationId xmlns:a16="http://schemas.microsoft.com/office/drawing/2014/main" id="{080ADE2C-A466-4B44-990E-5E5FE89361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50014" y="3019122"/>
                <a:ext cx="841841" cy="1345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49212" tIns="23812" rIns="49212" bIns="23812">
                <a:spAutoFit/>
              </a:bodyPr>
              <a:lstStyle>
                <a:lvl1pPr defTabSz="193675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marL="0" marR="0" lvl="0" indent="0" algn="ctr" defTabSz="1936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DBL-1X</a:t>
                </a:r>
              </a:p>
            </p:txBody>
          </p:sp>
          <p:sp>
            <p:nvSpPr>
              <p:cNvPr id="31" name="Rectangle 25">
                <a:extLst>
                  <a:ext uri="{FF2B5EF4-FFF2-40B4-BE49-F238E27FC236}">
                    <a16:creationId xmlns:a16="http://schemas.microsoft.com/office/drawing/2014/main" id="{FF5BB11E-3F9C-4A23-950C-25D3BE1317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70245" y="3016454"/>
                <a:ext cx="576944" cy="1297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49212" tIns="23812" rIns="49212" bIns="23812">
                <a:spAutoFit/>
              </a:bodyPr>
              <a:lstStyle>
                <a:lvl1pPr defTabSz="193675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marL="0" marR="0" lvl="0" indent="0" algn="l" defTabSz="1936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DBL-2X</a:t>
                </a:r>
              </a:p>
            </p:txBody>
          </p:sp>
          <p:sp>
            <p:nvSpPr>
              <p:cNvPr id="32" name="Rectangle 26">
                <a:extLst>
                  <a:ext uri="{FF2B5EF4-FFF2-40B4-BE49-F238E27FC236}">
                    <a16:creationId xmlns:a16="http://schemas.microsoft.com/office/drawing/2014/main" id="{BB9AAEAB-2360-464A-9932-C61AAAFF78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67954" y="3019719"/>
                <a:ext cx="725487" cy="1345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49212" tIns="23812" rIns="49212" bIns="23812">
                <a:spAutoFit/>
              </a:bodyPr>
              <a:lstStyle>
                <a:lvl1pPr defTabSz="193675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 defTabSz="193675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93675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marL="0" marR="0" lvl="0" indent="0" algn="l" defTabSz="1936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altLang="en-US" sz="10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DBL-3X</a:t>
                </a:r>
              </a:p>
            </p:txBody>
          </p:sp>
        </p:grp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D8729C37-B8A9-4EB5-9FC2-C93976A476A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96271" y="2671716"/>
              <a:ext cx="593432" cy="264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fr-FR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IDR</a:t>
              </a:r>
            </a:p>
          </p:txBody>
        </p:sp>
        <p:sp>
          <p:nvSpPr>
            <p:cNvPr id="5" name="Accolade ouvrante 5">
              <a:extLst>
                <a:ext uri="{FF2B5EF4-FFF2-40B4-BE49-F238E27FC236}">
                  <a16:creationId xmlns:a16="http://schemas.microsoft.com/office/drawing/2014/main" id="{20734F67-D7DE-4099-A44F-B8CE63A2B20D}"/>
                </a:ext>
              </a:extLst>
            </p:cNvPr>
            <p:cNvSpPr/>
            <p:nvPr/>
          </p:nvSpPr>
          <p:spPr>
            <a:xfrm rot="5400000" flipV="1">
              <a:off x="2783580" y="402003"/>
              <a:ext cx="390063" cy="3010886"/>
            </a:xfrm>
            <a:prstGeom prst="leftBrac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ZoneTexte 6">
              <a:extLst>
                <a:ext uri="{FF2B5EF4-FFF2-40B4-BE49-F238E27FC236}">
                  <a16:creationId xmlns:a16="http://schemas.microsoft.com/office/drawing/2014/main" id="{0885DEBC-1A93-43C6-A22D-407248F150E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62335" y="1464043"/>
              <a:ext cx="1903123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fr-FR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VAR2CSA DBL1-3</a:t>
              </a:r>
            </a:p>
          </p:txBody>
        </p:sp>
        <p:sp>
          <p:nvSpPr>
            <p:cNvPr id="7" name="ZoneTexte 70">
              <a:extLst>
                <a:ext uri="{FF2B5EF4-FFF2-40B4-BE49-F238E27FC236}">
                  <a16:creationId xmlns:a16="http://schemas.microsoft.com/office/drawing/2014/main" id="{67EF67D8-0178-4646-B59E-D1D0B71A2B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57264" y="2648331"/>
              <a:ext cx="523875" cy="264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fr-FR" sz="105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D1</a:t>
              </a:r>
            </a:p>
          </p:txBody>
        </p:sp>
        <p:sp>
          <p:nvSpPr>
            <p:cNvPr id="8" name="ZoneTexte 71">
              <a:extLst>
                <a:ext uri="{FF2B5EF4-FFF2-40B4-BE49-F238E27FC236}">
                  <a16:creationId xmlns:a16="http://schemas.microsoft.com/office/drawing/2014/main" id="{2276A37C-A733-4F7C-81D2-DB2E4943CD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50667" y="2098199"/>
              <a:ext cx="251984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fr-FR" sz="9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 S429 S433               T934  Y998  </a:t>
              </a:r>
            </a:p>
          </p:txBody>
        </p:sp>
        <p:cxnSp>
          <p:nvCxnSpPr>
            <p:cNvPr id="9" name="Connecteur droit avec flèche 8">
              <a:extLst>
                <a:ext uri="{FF2B5EF4-FFF2-40B4-BE49-F238E27FC236}">
                  <a16:creationId xmlns:a16="http://schemas.microsoft.com/office/drawing/2014/main" id="{DB978CD2-0BAF-4F5C-BF36-565A9E9AE6C0}"/>
                </a:ext>
              </a:extLst>
            </p:cNvPr>
            <p:cNvCxnSpPr>
              <a:cxnSpLocks/>
            </p:cNvCxnSpPr>
            <p:nvPr/>
          </p:nvCxnSpPr>
          <p:spPr>
            <a:xfrm>
              <a:off x="2373415" y="2331246"/>
              <a:ext cx="0" cy="23971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cteur droit avec flèche 9">
              <a:extLst>
                <a:ext uri="{FF2B5EF4-FFF2-40B4-BE49-F238E27FC236}">
                  <a16:creationId xmlns:a16="http://schemas.microsoft.com/office/drawing/2014/main" id="{C29C649B-8FBE-4669-B8F8-89564AB83876}"/>
                </a:ext>
              </a:extLst>
            </p:cNvPr>
            <p:cNvCxnSpPr>
              <a:cxnSpLocks/>
            </p:cNvCxnSpPr>
            <p:nvPr/>
          </p:nvCxnSpPr>
          <p:spPr>
            <a:xfrm>
              <a:off x="2549752" y="2329658"/>
              <a:ext cx="0" cy="23971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necteur droit avec flèche 10">
              <a:extLst>
                <a:ext uri="{FF2B5EF4-FFF2-40B4-BE49-F238E27FC236}">
                  <a16:creationId xmlns:a16="http://schemas.microsoft.com/office/drawing/2014/main" id="{93B809BE-B024-4C72-A613-D24F61410C96}"/>
                </a:ext>
              </a:extLst>
            </p:cNvPr>
            <p:cNvCxnSpPr>
              <a:cxnSpLocks/>
            </p:cNvCxnSpPr>
            <p:nvPr/>
          </p:nvCxnSpPr>
          <p:spPr>
            <a:xfrm>
              <a:off x="1713693" y="2329658"/>
              <a:ext cx="0" cy="23971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cteur droit avec flèche 11">
              <a:extLst>
                <a:ext uri="{FF2B5EF4-FFF2-40B4-BE49-F238E27FC236}">
                  <a16:creationId xmlns:a16="http://schemas.microsoft.com/office/drawing/2014/main" id="{DFFC6F84-952F-406C-B119-499531BC079B}"/>
                </a:ext>
              </a:extLst>
            </p:cNvPr>
            <p:cNvCxnSpPr>
              <a:cxnSpLocks/>
            </p:cNvCxnSpPr>
            <p:nvPr/>
          </p:nvCxnSpPr>
          <p:spPr>
            <a:xfrm>
              <a:off x="1916893" y="2329657"/>
              <a:ext cx="0" cy="23971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ZoneTexte 71">
              <a:extLst>
                <a:ext uri="{FF2B5EF4-FFF2-40B4-BE49-F238E27FC236}">
                  <a16:creationId xmlns:a16="http://schemas.microsoft.com/office/drawing/2014/main" id="{AFF118CC-51F6-4527-BD78-6D1741DF35A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12929" y="2105968"/>
              <a:ext cx="89909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fr-FR" sz="9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267 Y271</a:t>
              </a:r>
            </a:p>
          </p:txBody>
        </p:sp>
        <p:cxnSp>
          <p:nvCxnSpPr>
            <p:cNvPr id="14" name="Connecteur droit avec flèche 13">
              <a:extLst>
                <a:ext uri="{FF2B5EF4-FFF2-40B4-BE49-F238E27FC236}">
                  <a16:creationId xmlns:a16="http://schemas.microsoft.com/office/drawing/2014/main" id="{EE98C1B0-101D-4210-B954-7FE135460A8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03661" y="2950520"/>
              <a:ext cx="0" cy="1482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cteur droit avec flèche 14">
              <a:extLst>
                <a:ext uri="{FF2B5EF4-FFF2-40B4-BE49-F238E27FC236}">
                  <a16:creationId xmlns:a16="http://schemas.microsoft.com/office/drawing/2014/main" id="{B08B384A-01C2-4E84-BD75-4F8ECA48B31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17420" y="2950520"/>
              <a:ext cx="0" cy="1482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cteur droit avec flèche 15">
              <a:extLst>
                <a:ext uri="{FF2B5EF4-FFF2-40B4-BE49-F238E27FC236}">
                  <a16:creationId xmlns:a16="http://schemas.microsoft.com/office/drawing/2014/main" id="{5912BBC2-F04A-4FE9-98A0-CF94C16E49DC}"/>
                </a:ext>
              </a:extLst>
            </p:cNvPr>
            <p:cNvCxnSpPr>
              <a:cxnSpLocks/>
            </p:cNvCxnSpPr>
            <p:nvPr/>
          </p:nvCxnSpPr>
          <p:spPr>
            <a:xfrm>
              <a:off x="3529862" y="2353776"/>
              <a:ext cx="0" cy="23971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cteur droit avec flèche 16">
              <a:extLst>
                <a:ext uri="{FF2B5EF4-FFF2-40B4-BE49-F238E27FC236}">
                  <a16:creationId xmlns:a16="http://schemas.microsoft.com/office/drawing/2014/main" id="{68FBF1F8-0C01-4755-A665-1E20D349AC7E}"/>
                </a:ext>
              </a:extLst>
            </p:cNvPr>
            <p:cNvCxnSpPr>
              <a:cxnSpLocks/>
            </p:cNvCxnSpPr>
            <p:nvPr/>
          </p:nvCxnSpPr>
          <p:spPr>
            <a:xfrm>
              <a:off x="3794974" y="2352189"/>
              <a:ext cx="0" cy="23971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ZoneTexte 71">
              <a:extLst>
                <a:ext uri="{FF2B5EF4-FFF2-40B4-BE49-F238E27FC236}">
                  <a16:creationId xmlns:a16="http://schemas.microsoft.com/office/drawing/2014/main" id="{CABF7099-EAF6-4B40-AA14-9AE1E07FAC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78976" y="3096706"/>
              <a:ext cx="17075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fr-FR" sz="9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1006 T1007 </a:t>
              </a:r>
            </a:p>
          </p:txBody>
        </p:sp>
        <p:sp>
          <p:nvSpPr>
            <p:cNvPr id="19" name="Ellipse 18">
              <a:extLst>
                <a:ext uri="{FF2B5EF4-FFF2-40B4-BE49-F238E27FC236}">
                  <a16:creationId xmlns:a16="http://schemas.microsoft.com/office/drawing/2014/main" id="{7703F9E3-F5B9-4897-8C04-31942D9857B5}"/>
                </a:ext>
              </a:extLst>
            </p:cNvPr>
            <p:cNvSpPr/>
            <p:nvPr/>
          </p:nvSpPr>
          <p:spPr>
            <a:xfrm>
              <a:off x="3186821" y="2085401"/>
              <a:ext cx="382031" cy="24622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37552276-8A98-47A5-A1D2-1ED730FDD9B2}"/>
                </a:ext>
              </a:extLst>
            </p:cNvPr>
            <p:cNvSpPr/>
            <p:nvPr/>
          </p:nvSpPr>
          <p:spPr>
            <a:xfrm>
              <a:off x="2373415" y="3096706"/>
              <a:ext cx="45397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altLang="fr-F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452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Connecteur droit avec flèche 20">
              <a:extLst>
                <a:ext uri="{FF2B5EF4-FFF2-40B4-BE49-F238E27FC236}">
                  <a16:creationId xmlns:a16="http://schemas.microsoft.com/office/drawing/2014/main" id="{CC3B7033-3732-486B-99EE-EF04A93B587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09334" y="2949889"/>
              <a:ext cx="0" cy="1482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Ellipse 21">
              <a:extLst>
                <a:ext uri="{FF2B5EF4-FFF2-40B4-BE49-F238E27FC236}">
                  <a16:creationId xmlns:a16="http://schemas.microsoft.com/office/drawing/2014/main" id="{63C0C578-04AF-46DB-8BAB-24B6A585C370}"/>
                </a:ext>
              </a:extLst>
            </p:cNvPr>
            <p:cNvSpPr/>
            <p:nvPr/>
          </p:nvSpPr>
          <p:spPr>
            <a:xfrm>
              <a:off x="2159139" y="2087883"/>
              <a:ext cx="670012" cy="24622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Rectangle 32">
            <a:extLst>
              <a:ext uri="{FF2B5EF4-FFF2-40B4-BE49-F238E27FC236}">
                <a16:creationId xmlns:a16="http://schemas.microsoft.com/office/drawing/2014/main" id="{F86172CC-9A46-4615-9E3C-5FEDE82FAF87}"/>
              </a:ext>
            </a:extLst>
          </p:cNvPr>
          <p:cNvSpPr/>
          <p:nvPr/>
        </p:nvSpPr>
        <p:spPr>
          <a:xfrm>
            <a:off x="5135310" y="1448037"/>
            <a:ext cx="218149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fr-FR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figure 5</a:t>
            </a:r>
            <a:endParaRPr kumimoji="0" lang="fr-FR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33794976"/>
      </p:ext>
    </p:extLst>
  </p:cSld>
  <p:clrMapOvr>
    <a:masterClrMapping/>
  </p:clrMapOvr>
</p:sld>
</file>

<file path=ppt/theme/theme1.xml><?xml version="1.0" encoding="utf-8"?>
<a:theme xmlns:a="http://schemas.openxmlformats.org/drawingml/2006/main" name="1_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66</TotalTime>
  <Words>218</Words>
  <Application>Microsoft Office PowerPoint</Application>
  <PresentationFormat>Grand écran</PresentationFormat>
  <Paragraphs>82</Paragraphs>
  <Slides>5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0" baseType="lpstr">
      <vt:lpstr>MS PGothic</vt:lpstr>
      <vt:lpstr>Arial</vt:lpstr>
      <vt:lpstr>Calibri</vt:lpstr>
      <vt:lpstr>Calibri Light</vt:lpstr>
      <vt:lpstr>1_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ominique Dorin-Semblat</dc:creator>
  <cp:lastModifiedBy>benoit gamain</cp:lastModifiedBy>
  <cp:revision>15</cp:revision>
  <dcterms:created xsi:type="dcterms:W3CDTF">2026-01-14T21:15:52Z</dcterms:created>
  <dcterms:modified xsi:type="dcterms:W3CDTF">2026-03-19T11:39:17Z</dcterms:modified>
</cp:coreProperties>
</file>